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6" r:id="rId3"/>
    <p:sldId id="265" r:id="rId4"/>
    <p:sldId id="258" r:id="rId5"/>
    <p:sldId id="257" r:id="rId6"/>
    <p:sldId id="266" r:id="rId7"/>
    <p:sldId id="267" r:id="rId8"/>
    <p:sldId id="262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368" autoAdjust="0"/>
    <p:restoredTop sz="94660"/>
  </p:normalViewPr>
  <p:slideViewPr>
    <p:cSldViewPr snapToGrid="0">
      <p:cViewPr varScale="1">
        <p:scale>
          <a:sx n="72" d="100"/>
          <a:sy n="72" d="100"/>
        </p:scale>
        <p:origin x="105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00C032-096A-40BC-A15D-DBBBD87951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4941958-557D-4EE3-9FE2-D2A7A15FDC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4A8ECA-2B3F-4791-83A0-7D66227BF4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DC423-F34D-4DF2-B9CF-9178ED0C85AE}" type="datetimeFigureOut">
              <a:rPr lang="en-IN" smtClean="0"/>
              <a:t>02-06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9376BD-9CD8-4BA0-9CB5-5A017E900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2904BB-91F4-4B64-9910-2490B3538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A0C4A-AD2E-47BF-AC04-D7369A53A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8621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030480-AC07-412C-858C-51D1CA0217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11E1A8-53E4-4A70-B57E-1300276C37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79CD6E-0505-48C2-BA6C-3443C7FAD2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DC423-F34D-4DF2-B9CF-9178ED0C85AE}" type="datetimeFigureOut">
              <a:rPr lang="en-IN" smtClean="0"/>
              <a:t>02-06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FD3A27-0A57-4A42-A40B-77D896E9B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4AB4A5-82C1-4682-AF82-5B3E3C41D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A0C4A-AD2E-47BF-AC04-D7369A53A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08659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17543CC-B1B8-427C-A625-30C04DA56B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21AB1B-68AF-4261-9B44-631A485F07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C01112-4378-4509-839C-AF3655F808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DC423-F34D-4DF2-B9CF-9178ED0C85AE}" type="datetimeFigureOut">
              <a:rPr lang="en-IN" smtClean="0"/>
              <a:t>02-06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EFC1E9-E842-4588-90D3-43E79F1621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571D92-B43F-4A48-BD3C-6C355252C7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A0C4A-AD2E-47BF-AC04-D7369A53A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89776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B5527-0E57-4EAF-887D-2ADC3366F9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86AE27-5A3D-4A18-B1C6-F11EB924C0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5EBFFB-2CA0-4FA0-8454-9F214ECE1B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DC423-F34D-4DF2-B9CF-9178ED0C85AE}" type="datetimeFigureOut">
              <a:rPr lang="en-IN" smtClean="0"/>
              <a:t>02-06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4DBE3B-5CC7-4F9A-B94F-C9E0920377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62895D-1E3D-4156-B1AC-1A2CE22323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A0C4A-AD2E-47BF-AC04-D7369A53A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99557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520536-8E27-4E2E-AF84-341EC30AE1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E98EAF-FF24-4516-AA36-DEA9A8F1FB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D181BD-4C30-440C-92AA-A9B29BD604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DC423-F34D-4DF2-B9CF-9178ED0C85AE}" type="datetimeFigureOut">
              <a:rPr lang="en-IN" smtClean="0"/>
              <a:t>02-06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4CB70A-CB33-4A20-B759-76310536BB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65EB5F-221C-4F62-937B-D99170BE6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A0C4A-AD2E-47BF-AC04-D7369A53A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6348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A8BFB9-6E03-49F4-828B-D4EE60294B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F4E955-3E22-40EA-BD60-C861694440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3023F9-3D59-4560-B9D8-A6D860899D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95C4BA-458E-480B-AC93-1F2CF1F1D9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DC423-F34D-4DF2-B9CF-9178ED0C85AE}" type="datetimeFigureOut">
              <a:rPr lang="en-IN" smtClean="0"/>
              <a:t>02-06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46E7B5-7950-4239-893A-21D0BDB850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4FB87F-DD83-422D-BEE2-B856C904F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A0C4A-AD2E-47BF-AC04-D7369A53A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92395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8163A1-2171-4DCC-B44E-FF72078433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EC8A66-E05C-409B-94F1-A860E0F136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D3BA47C-565A-434C-9BC2-C77BF00D9D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971A38-474A-4ABB-B882-F337A61F2F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EA82EC6-3B61-4651-AEB6-D781F6C9A3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0E05984-D310-4AAB-99F6-6ACC4C562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DC423-F34D-4DF2-B9CF-9178ED0C85AE}" type="datetimeFigureOut">
              <a:rPr lang="en-IN" smtClean="0"/>
              <a:t>02-06-2021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47AAF5E-D995-44A5-8F19-D352954C4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2DB89A-A9DE-4E66-8787-AACB34082F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A0C4A-AD2E-47BF-AC04-D7369A53A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580194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320787-423C-4CB8-B868-C129A485A5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24E4E8D-7FED-4465-8482-9F1177538E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DC423-F34D-4DF2-B9CF-9178ED0C85AE}" type="datetimeFigureOut">
              <a:rPr lang="en-IN" smtClean="0"/>
              <a:t>02-06-2021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DD5856E-CC09-48B2-9295-AC14AE4E0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658445E-BD73-4B39-9686-F6DA2B2A6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A0C4A-AD2E-47BF-AC04-D7369A53A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9371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62EF257-366B-4E6C-83EA-81CD0D3CB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DC423-F34D-4DF2-B9CF-9178ED0C85AE}" type="datetimeFigureOut">
              <a:rPr lang="en-IN" smtClean="0"/>
              <a:t>02-06-2021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95AC1CE-9856-4FE6-A52D-98C4BD4350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E5D826-C264-46B9-8140-C3DCA5DDD3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A0C4A-AD2E-47BF-AC04-D7369A53A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123116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EA5022-14AD-47C9-AA28-FB00E9CD5B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E7F7E7-3F8C-493F-A440-6BD7E6F1A4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00FCF73-3374-4984-977E-4616FD84AD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F077DF-360C-41D1-8A67-B97D5033A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DC423-F34D-4DF2-B9CF-9178ED0C85AE}" type="datetimeFigureOut">
              <a:rPr lang="en-IN" smtClean="0"/>
              <a:t>02-06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AC45AB-FEF8-44C9-AB9B-BEAEF2A1B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4C2BAC-2934-461C-A759-ECF931C68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A0C4A-AD2E-47BF-AC04-D7369A53A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1663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A008FC-0DDB-4987-8EFA-4BBD5EC643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2522A57-3B4D-43AC-A7C8-64419BB7C1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0B7DD7-7265-4450-B2B7-8141CAFE06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5AFCB5-3EC8-4B50-914F-CAAB718D9F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DC423-F34D-4DF2-B9CF-9178ED0C85AE}" type="datetimeFigureOut">
              <a:rPr lang="en-IN" smtClean="0"/>
              <a:t>02-06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798B65-1F2D-4CE2-942A-9D991F6EC1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6B2952-74CC-43D2-A8CD-B1C80BAB5B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A0C4A-AD2E-47BF-AC04-D7369A53A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81063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557D0CD-766C-4CC5-883D-C0CDE2BB49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CC49D8-4726-49BD-9689-461D0ACB85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57758E-A2C3-4919-9932-36F6D71F5D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DDC423-F34D-4DF2-B9CF-9178ED0C85AE}" type="datetimeFigureOut">
              <a:rPr lang="en-IN" smtClean="0"/>
              <a:t>02-06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D72947-1943-499B-A394-DAF1EED43E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C9A35E-21F5-4756-81C8-1E8E485AB5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EA0C4A-AD2E-47BF-AC04-D7369A53AC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01777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7" Type="http://schemas.openxmlformats.org/officeDocument/2006/relationships/image" Target="../media/image11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7" Type="http://schemas.openxmlformats.org/officeDocument/2006/relationships/image" Target="../media/image17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emf"/><Relationship Id="rId5" Type="http://schemas.openxmlformats.org/officeDocument/2006/relationships/image" Target="../media/image15.emf"/><Relationship Id="rId4" Type="http://schemas.openxmlformats.org/officeDocument/2006/relationships/image" Target="../media/image14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0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7" Type="http://schemas.openxmlformats.org/officeDocument/2006/relationships/image" Target="../media/image26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emf"/><Relationship Id="rId5" Type="http://schemas.openxmlformats.org/officeDocument/2006/relationships/image" Target="../media/image24.emf"/><Relationship Id="rId4" Type="http://schemas.openxmlformats.org/officeDocument/2006/relationships/image" Target="../media/image23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4315023-AF30-4D25-95DA-2E5DA3ABAFD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65" r="10865"/>
          <a:stretch/>
        </p:blipFill>
        <p:spPr>
          <a:xfrm>
            <a:off x="861391" y="268590"/>
            <a:ext cx="9753600" cy="65894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8AF3F80-2979-4A45-A2B8-9A8EF8A912EC}"/>
              </a:ext>
            </a:extLst>
          </p:cNvPr>
          <p:cNvSpPr txBox="1"/>
          <p:nvPr/>
        </p:nvSpPr>
        <p:spPr>
          <a:xfrm>
            <a:off x="4916557" y="0"/>
            <a:ext cx="2226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25502618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>
            <a:extLst>
              <a:ext uri="{FF2B5EF4-FFF2-40B4-BE49-F238E27FC236}">
                <a16:creationId xmlns:a16="http://schemas.microsoft.com/office/drawing/2014/main" id="{0173315A-5CFA-401E-88EE-551C43B0028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13" r="28041"/>
          <a:stretch/>
        </p:blipFill>
        <p:spPr>
          <a:xfrm>
            <a:off x="790074" y="868017"/>
            <a:ext cx="4872703" cy="4439478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09BC0EBC-0ABE-4D4E-9608-17FD80A6FA4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0869"/>
          <a:stretch/>
        </p:blipFill>
        <p:spPr>
          <a:xfrm>
            <a:off x="6529224" y="768626"/>
            <a:ext cx="4875376" cy="463826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5790322-4BDA-4A64-8F4E-6F0E815707A7}"/>
              </a:ext>
            </a:extLst>
          </p:cNvPr>
          <p:cNvSpPr txBox="1"/>
          <p:nvPr/>
        </p:nvSpPr>
        <p:spPr>
          <a:xfrm>
            <a:off x="4916557" y="0"/>
            <a:ext cx="2226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A6A5818-9F27-4DF5-B5BF-BB9161410A25}"/>
              </a:ext>
            </a:extLst>
          </p:cNvPr>
          <p:cNvSpPr txBox="1"/>
          <p:nvPr/>
        </p:nvSpPr>
        <p:spPr>
          <a:xfrm>
            <a:off x="568885" y="399294"/>
            <a:ext cx="442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A80162C-899A-45B2-9AB8-FA0CA09A0AC2}"/>
              </a:ext>
            </a:extLst>
          </p:cNvPr>
          <p:cNvSpPr txBox="1"/>
          <p:nvPr/>
        </p:nvSpPr>
        <p:spPr>
          <a:xfrm>
            <a:off x="6700544" y="399294"/>
            <a:ext cx="442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8886650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93C7154-9273-4516-84CF-91A438B27D7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1088"/>
          <a:stretch/>
        </p:blipFill>
        <p:spPr>
          <a:xfrm>
            <a:off x="593" y="0"/>
            <a:ext cx="4743686" cy="6858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B047524-440E-41E2-830C-98CD3135EDCE}"/>
              </a:ext>
            </a:extLst>
          </p:cNvPr>
          <p:cNvSpPr txBox="1"/>
          <p:nvPr/>
        </p:nvSpPr>
        <p:spPr>
          <a:xfrm>
            <a:off x="4916557" y="0"/>
            <a:ext cx="2226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3C83B1D-1133-472D-8CC9-855DC3ED0B2C}"/>
              </a:ext>
            </a:extLst>
          </p:cNvPr>
          <p:cNvSpPr txBox="1"/>
          <p:nvPr/>
        </p:nvSpPr>
        <p:spPr>
          <a:xfrm>
            <a:off x="132522" y="225287"/>
            <a:ext cx="3710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A301C24-98A2-4A0F-B8E2-AFC8102F0E41}"/>
              </a:ext>
            </a:extLst>
          </p:cNvPr>
          <p:cNvSpPr txBox="1"/>
          <p:nvPr/>
        </p:nvSpPr>
        <p:spPr>
          <a:xfrm>
            <a:off x="7719391" y="219525"/>
            <a:ext cx="430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b)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7DA06EAB-B5A5-4D43-A854-CE49ADB262E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1739" r="4561" b="51665"/>
          <a:stretch/>
        </p:blipFill>
        <p:spPr>
          <a:xfrm>
            <a:off x="6651998" y="588857"/>
            <a:ext cx="5539409" cy="319550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1222648F-CFBB-4FC1-AE11-4D9C788C904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022" t="68515" r="4561" b="19117"/>
          <a:stretch/>
        </p:blipFill>
        <p:spPr>
          <a:xfrm>
            <a:off x="7142922" y="5168348"/>
            <a:ext cx="5049078" cy="848138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FAB80B10-7B14-4A23-AD2F-356B362CFA08}"/>
              </a:ext>
            </a:extLst>
          </p:cNvPr>
          <p:cNvSpPr txBox="1"/>
          <p:nvPr/>
        </p:nvSpPr>
        <p:spPr>
          <a:xfrm>
            <a:off x="7719391" y="4599369"/>
            <a:ext cx="430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c)</a:t>
            </a:r>
          </a:p>
        </p:txBody>
      </p:sp>
    </p:spTree>
    <p:extLst>
      <p:ext uri="{BB962C8B-B14F-4D97-AF65-F5344CB8AC3E}">
        <p14:creationId xmlns:p14="http://schemas.microsoft.com/office/powerpoint/2010/main" val="34425723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DBBBCBB-417A-4809-B988-69A423AFD8CF}"/>
              </a:ext>
            </a:extLst>
          </p:cNvPr>
          <p:cNvGrpSpPr/>
          <p:nvPr/>
        </p:nvGrpSpPr>
        <p:grpSpPr>
          <a:xfrm>
            <a:off x="874644" y="331305"/>
            <a:ext cx="10372512" cy="6526696"/>
            <a:chOff x="593" y="-39757"/>
            <a:chExt cx="10712535" cy="6897757"/>
          </a:xfrm>
        </p:grpSpPr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11E65F4F-CA28-4DBA-9120-420202D0D8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5108"/>
            <a:stretch/>
          </p:blipFill>
          <p:spPr>
            <a:xfrm>
              <a:off x="593" y="-39757"/>
              <a:ext cx="3345878" cy="3429000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08AB9171-CD44-4860-B006-E7021E14C2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5434"/>
            <a:stretch/>
          </p:blipFill>
          <p:spPr>
            <a:xfrm>
              <a:off x="20471" y="3360191"/>
              <a:ext cx="3326000" cy="3429000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DDC1E3F5-DD2D-4173-96E0-6925E56705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5434"/>
            <a:stretch/>
          </p:blipFill>
          <p:spPr>
            <a:xfrm>
              <a:off x="3717532" y="-1"/>
              <a:ext cx="3326000" cy="3429001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874BA01B-C1B3-4D69-B185-BB0B000071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5978"/>
            <a:stretch/>
          </p:blipFill>
          <p:spPr>
            <a:xfrm>
              <a:off x="3717532" y="3373800"/>
              <a:ext cx="3345878" cy="3484200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C1F4E8D8-C706-4D66-80F6-B1FC39619D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4999"/>
            <a:stretch/>
          </p:blipFill>
          <p:spPr>
            <a:xfrm>
              <a:off x="7414593" y="-1"/>
              <a:ext cx="3298535" cy="3373800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0922D547-2D1C-482B-87BD-8434328713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5217"/>
            <a:stretch/>
          </p:blipFill>
          <p:spPr>
            <a:xfrm>
              <a:off x="7387128" y="3373799"/>
              <a:ext cx="3326000" cy="3415392"/>
            </a:xfrm>
            <a:prstGeom prst="rect">
              <a:avLst/>
            </a:prstGeom>
          </p:spPr>
        </p:pic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2EDF391C-273B-43E0-A23A-2EF698B2BA01}"/>
              </a:ext>
            </a:extLst>
          </p:cNvPr>
          <p:cNvSpPr txBox="1"/>
          <p:nvPr/>
        </p:nvSpPr>
        <p:spPr>
          <a:xfrm>
            <a:off x="4916557" y="0"/>
            <a:ext cx="2226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21794395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040989F8-50E9-4500-AFA5-FBAF0A05539B}"/>
              </a:ext>
            </a:extLst>
          </p:cNvPr>
          <p:cNvGrpSpPr/>
          <p:nvPr/>
        </p:nvGrpSpPr>
        <p:grpSpPr>
          <a:xfrm>
            <a:off x="304800" y="424069"/>
            <a:ext cx="11059756" cy="6315712"/>
            <a:chOff x="0" y="229611"/>
            <a:chExt cx="11059756" cy="6496918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ECCF2EE0-97F5-483A-BCF2-299B46C353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646" t="3865" r="20538"/>
            <a:stretch/>
          </p:blipFill>
          <p:spPr>
            <a:xfrm>
              <a:off x="0" y="350464"/>
              <a:ext cx="3474000" cy="2944319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909E5C7A-11FF-4EAB-A6BC-91564FF8D1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688" r="22228"/>
            <a:stretch/>
          </p:blipFill>
          <p:spPr>
            <a:xfrm>
              <a:off x="7468233" y="3555487"/>
              <a:ext cx="3591523" cy="3111462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1F2759A-C538-4801-AD0C-B688FCC758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411" t="2884" r="19019"/>
            <a:stretch/>
          </p:blipFill>
          <p:spPr>
            <a:xfrm>
              <a:off x="3734116" y="229611"/>
              <a:ext cx="3474000" cy="3186024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A2DAC9A6-8373-496D-9FD6-A077E709AF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83" r="34890"/>
            <a:stretch/>
          </p:blipFill>
          <p:spPr>
            <a:xfrm>
              <a:off x="7468232" y="234117"/>
              <a:ext cx="3474000" cy="3181518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E4BCD18F-7324-481C-BDFD-5A7B2EB4AB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35" t="1353" r="34672" b="5111"/>
            <a:stretch/>
          </p:blipFill>
          <p:spPr>
            <a:xfrm>
              <a:off x="14973" y="3579396"/>
              <a:ext cx="3612490" cy="3111461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B73EEE78-BC39-4C60-A624-A86732C4EF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96" t="2437" r="35651" b="5111"/>
            <a:stretch/>
          </p:blipFill>
          <p:spPr>
            <a:xfrm>
              <a:off x="3755083" y="3579396"/>
              <a:ext cx="3591523" cy="3147133"/>
            </a:xfrm>
            <a:prstGeom prst="rect">
              <a:avLst/>
            </a:prstGeom>
          </p:spPr>
        </p:pic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871F993B-0B92-4BED-8A18-4AB6DD500590}"/>
              </a:ext>
            </a:extLst>
          </p:cNvPr>
          <p:cNvSpPr txBox="1"/>
          <p:nvPr/>
        </p:nvSpPr>
        <p:spPr>
          <a:xfrm>
            <a:off x="4916557" y="0"/>
            <a:ext cx="2226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758E89B-ABB3-4AED-A6CE-F0A40E52DA3E}"/>
              </a:ext>
            </a:extLst>
          </p:cNvPr>
          <p:cNvSpPr txBox="1"/>
          <p:nvPr/>
        </p:nvSpPr>
        <p:spPr>
          <a:xfrm>
            <a:off x="132522" y="225287"/>
            <a:ext cx="3710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a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969724C-71F9-44D8-92DB-6C48A143D0DB}"/>
              </a:ext>
            </a:extLst>
          </p:cNvPr>
          <p:cNvSpPr txBox="1"/>
          <p:nvPr/>
        </p:nvSpPr>
        <p:spPr>
          <a:xfrm>
            <a:off x="3951079" y="193021"/>
            <a:ext cx="448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b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861872D-9FBE-477C-996F-2B560DAF8744}"/>
              </a:ext>
            </a:extLst>
          </p:cNvPr>
          <p:cNvSpPr txBox="1"/>
          <p:nvPr/>
        </p:nvSpPr>
        <p:spPr>
          <a:xfrm>
            <a:off x="7659440" y="193021"/>
            <a:ext cx="448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c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E1D8AD1-17C7-4689-BF2E-C9EA48C9E52E}"/>
              </a:ext>
            </a:extLst>
          </p:cNvPr>
          <p:cNvSpPr txBox="1"/>
          <p:nvPr/>
        </p:nvSpPr>
        <p:spPr>
          <a:xfrm>
            <a:off x="131562" y="3521231"/>
            <a:ext cx="448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d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0ECA2F5-AE94-4BEF-993D-F7A99D758A4B}"/>
              </a:ext>
            </a:extLst>
          </p:cNvPr>
          <p:cNvSpPr txBox="1"/>
          <p:nvPr/>
        </p:nvSpPr>
        <p:spPr>
          <a:xfrm>
            <a:off x="3951079" y="3509858"/>
            <a:ext cx="448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e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6CA0DAA-6D30-4904-8D70-0B78403249A6}"/>
              </a:ext>
            </a:extLst>
          </p:cNvPr>
          <p:cNvSpPr txBox="1"/>
          <p:nvPr/>
        </p:nvSpPr>
        <p:spPr>
          <a:xfrm>
            <a:off x="7627575" y="3521231"/>
            <a:ext cx="448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f)</a:t>
            </a:r>
          </a:p>
        </p:txBody>
      </p:sp>
    </p:spTree>
    <p:extLst>
      <p:ext uri="{BB962C8B-B14F-4D97-AF65-F5344CB8AC3E}">
        <p14:creationId xmlns:p14="http://schemas.microsoft.com/office/powerpoint/2010/main" val="42106765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BB1A74D-72EF-4262-8539-DEEB7650991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78" r="36846"/>
          <a:stretch/>
        </p:blipFill>
        <p:spPr>
          <a:xfrm>
            <a:off x="286074" y="71814"/>
            <a:ext cx="3749774" cy="322402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59FC693-01BD-42AF-9325-225D4CD2987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0558" y="0"/>
            <a:ext cx="5750850" cy="323516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8B3E467-97BA-4FF8-B24B-E361FD115EA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9921" y="3356500"/>
            <a:ext cx="6224285" cy="35015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4D5D9DB7-BD86-4C6B-8B88-E431BA40595C}"/>
              </a:ext>
            </a:extLst>
          </p:cNvPr>
          <p:cNvSpPr txBox="1"/>
          <p:nvPr/>
        </p:nvSpPr>
        <p:spPr>
          <a:xfrm>
            <a:off x="4916557" y="0"/>
            <a:ext cx="2226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126C6A2-E0AD-4669-ADAD-29F99DA61F98}"/>
              </a:ext>
            </a:extLst>
          </p:cNvPr>
          <p:cNvSpPr txBox="1"/>
          <p:nvPr/>
        </p:nvSpPr>
        <p:spPr>
          <a:xfrm>
            <a:off x="54407" y="14117"/>
            <a:ext cx="448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g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B077F2E-2E85-452D-9C49-9012034AF28C}"/>
              </a:ext>
            </a:extLst>
          </p:cNvPr>
          <p:cNvSpPr txBox="1"/>
          <p:nvPr/>
        </p:nvSpPr>
        <p:spPr>
          <a:xfrm>
            <a:off x="6918442" y="0"/>
            <a:ext cx="448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h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52C10CA-814A-4684-AED1-DB08F8930D59}"/>
              </a:ext>
            </a:extLst>
          </p:cNvPr>
          <p:cNvSpPr txBox="1"/>
          <p:nvPr/>
        </p:nvSpPr>
        <p:spPr>
          <a:xfrm>
            <a:off x="2160961" y="3429000"/>
            <a:ext cx="448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i)</a:t>
            </a:r>
          </a:p>
        </p:txBody>
      </p:sp>
    </p:spTree>
    <p:extLst>
      <p:ext uri="{BB962C8B-B14F-4D97-AF65-F5344CB8AC3E}">
        <p14:creationId xmlns:p14="http://schemas.microsoft.com/office/powerpoint/2010/main" val="28739095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5510126-31A4-46B2-82B5-9381CF2B3F3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5324"/>
          <a:stretch/>
        </p:blipFill>
        <p:spPr>
          <a:xfrm>
            <a:off x="690203" y="293529"/>
            <a:ext cx="3742708" cy="325545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BC32542-C4C6-4E8B-9250-97467A592A0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194"/>
          <a:stretch/>
        </p:blipFill>
        <p:spPr>
          <a:xfrm>
            <a:off x="4768386" y="250136"/>
            <a:ext cx="3697571" cy="326003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DC38C97-71A9-49D6-9FDA-39FF626D6A3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846"/>
          <a:stretch/>
        </p:blipFill>
        <p:spPr>
          <a:xfrm>
            <a:off x="8541303" y="293529"/>
            <a:ext cx="3571616" cy="318150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2EB66CD-8F38-4B6C-B66C-DD7B0C97240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1846"/>
          <a:stretch/>
        </p:blipFill>
        <p:spPr>
          <a:xfrm>
            <a:off x="570461" y="3548986"/>
            <a:ext cx="3974690" cy="328078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11AD159-EA42-4B0A-AFD0-6F3F934B7C51}"/>
              </a:ext>
            </a:extLst>
          </p:cNvPr>
          <p:cNvSpPr txBox="1"/>
          <p:nvPr/>
        </p:nvSpPr>
        <p:spPr>
          <a:xfrm>
            <a:off x="4916557" y="0"/>
            <a:ext cx="2226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BCCC6A5-A311-48BC-927E-6CC9C222282C}"/>
              </a:ext>
            </a:extLst>
          </p:cNvPr>
          <p:cNvSpPr txBox="1"/>
          <p:nvPr/>
        </p:nvSpPr>
        <p:spPr>
          <a:xfrm>
            <a:off x="359205" y="14117"/>
            <a:ext cx="448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a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EF1DB7A-24B5-439B-AA27-52790ED74ECF}"/>
              </a:ext>
            </a:extLst>
          </p:cNvPr>
          <p:cNvSpPr txBox="1"/>
          <p:nvPr/>
        </p:nvSpPr>
        <p:spPr>
          <a:xfrm>
            <a:off x="4432911" y="28234"/>
            <a:ext cx="448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b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D04386F-F546-4DB4-A725-5A82918461A7}"/>
              </a:ext>
            </a:extLst>
          </p:cNvPr>
          <p:cNvSpPr txBox="1"/>
          <p:nvPr/>
        </p:nvSpPr>
        <p:spPr>
          <a:xfrm>
            <a:off x="8541303" y="0"/>
            <a:ext cx="448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c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55A4533-03AF-4748-A20D-2FD772B90B14}"/>
              </a:ext>
            </a:extLst>
          </p:cNvPr>
          <p:cNvSpPr txBox="1"/>
          <p:nvPr/>
        </p:nvSpPr>
        <p:spPr>
          <a:xfrm>
            <a:off x="359205" y="3534869"/>
            <a:ext cx="448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d)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3EFC5A71-5B46-4822-BF0B-1B05E473F6B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520"/>
          <a:stretch/>
        </p:blipFill>
        <p:spPr>
          <a:xfrm>
            <a:off x="4763909" y="3577220"/>
            <a:ext cx="3702086" cy="328078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4B8A8111-E319-4E23-9ECB-D5D6349A415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629"/>
          <a:stretch/>
        </p:blipFill>
        <p:spPr>
          <a:xfrm>
            <a:off x="8684753" y="3744552"/>
            <a:ext cx="3507247" cy="3113447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FB821A3C-32FF-48C0-849A-F391B8686393}"/>
              </a:ext>
            </a:extLst>
          </p:cNvPr>
          <p:cNvSpPr txBox="1"/>
          <p:nvPr/>
        </p:nvSpPr>
        <p:spPr>
          <a:xfrm>
            <a:off x="4568578" y="3534869"/>
            <a:ext cx="448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e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63690C7-EB36-4CA5-BBB0-DF7489E95F27}"/>
              </a:ext>
            </a:extLst>
          </p:cNvPr>
          <p:cNvSpPr txBox="1"/>
          <p:nvPr/>
        </p:nvSpPr>
        <p:spPr>
          <a:xfrm>
            <a:off x="8541303" y="3475032"/>
            <a:ext cx="448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f)</a:t>
            </a:r>
          </a:p>
        </p:txBody>
      </p:sp>
    </p:spTree>
    <p:extLst>
      <p:ext uri="{BB962C8B-B14F-4D97-AF65-F5344CB8AC3E}">
        <p14:creationId xmlns:p14="http://schemas.microsoft.com/office/powerpoint/2010/main" val="329263919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F627C26-A488-4E2B-BA15-67EAF712AC6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24" r="37934"/>
          <a:stretch/>
        </p:blipFill>
        <p:spPr>
          <a:xfrm>
            <a:off x="198783" y="372136"/>
            <a:ext cx="3935896" cy="338816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A1E8852-D7E3-4F94-84E3-A766E0B6B9A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10" r="15866"/>
          <a:stretch/>
        </p:blipFill>
        <p:spPr>
          <a:xfrm>
            <a:off x="5585822" y="59635"/>
            <a:ext cx="6606178" cy="548747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2BA45B1-0184-4857-95B7-A5B1B6BD4489}"/>
              </a:ext>
            </a:extLst>
          </p:cNvPr>
          <p:cNvSpPr txBox="1"/>
          <p:nvPr/>
        </p:nvSpPr>
        <p:spPr>
          <a:xfrm>
            <a:off x="13252" y="187470"/>
            <a:ext cx="3710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B2054C-C471-46B2-8054-4A7D25D6623C}"/>
              </a:ext>
            </a:extLst>
          </p:cNvPr>
          <p:cNvSpPr txBox="1"/>
          <p:nvPr/>
        </p:nvSpPr>
        <p:spPr>
          <a:xfrm>
            <a:off x="8112261" y="187470"/>
            <a:ext cx="448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b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0D04487-DB3C-47DE-84BD-039728DBF9C9}"/>
              </a:ext>
            </a:extLst>
          </p:cNvPr>
          <p:cNvSpPr txBox="1"/>
          <p:nvPr/>
        </p:nvSpPr>
        <p:spPr>
          <a:xfrm>
            <a:off x="4916557" y="0"/>
            <a:ext cx="2226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</a:p>
        </p:txBody>
      </p:sp>
    </p:spTree>
    <p:extLst>
      <p:ext uri="{BB962C8B-B14F-4D97-AF65-F5344CB8AC3E}">
        <p14:creationId xmlns:p14="http://schemas.microsoft.com/office/powerpoint/2010/main" val="3613348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41</TotalTime>
  <Words>60</Words>
  <Application>Microsoft Office PowerPoint</Application>
  <PresentationFormat>Widescreen</PresentationFormat>
  <Paragraphs>30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gar Desai</dc:creator>
  <cp:lastModifiedBy>Sagar Desai</cp:lastModifiedBy>
  <cp:revision>42</cp:revision>
  <dcterms:created xsi:type="dcterms:W3CDTF">2020-12-29T10:35:05Z</dcterms:created>
  <dcterms:modified xsi:type="dcterms:W3CDTF">2021-06-01T18:54:47Z</dcterms:modified>
</cp:coreProperties>
</file>